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80" y="2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7D2CBB-C0C3-A21F-961F-4BB88DA9AF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5363710-3EDF-BCA7-4919-F615DF2B07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D139D63-BD03-33AE-C2D2-A1A37EFBF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59EF27-C746-0A38-C2E2-FFDC291BC9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AB6F8E-A3C1-87C9-FF5E-FC2FB5FD5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55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4745EB-CACD-B0D6-B945-598873324C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4D757FE-2B1C-9BA5-A82C-177E39ECD6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896C38-1DE6-1784-70A6-3A8C24FA5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1B2B3C-290C-553D-6A7C-BBC8548EC0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101D384-3295-D564-7166-5D2A917AF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111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00EE644-3427-4F48-DFFC-D59368CEE5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9846AC1-4285-2DCF-0C71-16AD2D131D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73B3F1-F9EC-6B2B-464C-CA4263160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595500-BD15-6E7B-FB38-4F5667930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7628AD-2F67-D1BF-F1B3-2CCC1125C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649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1EEFF6-00AA-D9AC-9644-C61059DF66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62196F-4202-6D5A-71F0-97D6E84136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AE31E9-238D-2BC9-C933-F7694A4BD5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D7D5EE-1B10-0F67-0C6A-AA6A357E0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BF564A-CA7B-7C95-7DEA-C56067F72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6750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47EC20-C645-3298-690B-D494DCE0E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0AAD93-5AB3-621F-DA99-B0A3C3E52D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AA3973-8C13-3755-4095-5BB767891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D58CBE-A171-D628-0A4A-990337DAC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C7C264-0821-7CCB-7F4B-02F1C7CE6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914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1E18E8-5140-0E20-6A8B-2CA4E04C4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F82068B-579E-1429-BFBE-6CF989C8C8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54EE52A-5EC7-01A9-446E-FD5A380B7B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26BC54-73C0-A3FB-4421-6258E4490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9AA06B5-1B7D-7796-31F7-590470C3D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54EBFED-CCEC-7D98-CB07-6599758EF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417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C094B4-267F-880C-7C97-3C705AD96C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9AD65F5-9A87-8FF4-047B-13B36149B4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534E5C3-BA47-15D7-5F4D-148F41A157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3D5967C-F040-6170-EB01-BCC280E188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AF71CA4-D071-C973-9F80-1A597946AB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DECA247-97A7-2FD0-1453-4FFFE9B07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F18E3F7-CA9C-5D41-2602-1C917480F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E29E573-2A67-A4E9-0336-4E75F698E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4591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A6C6D1-5D13-8A18-B0E2-0121EC6EC2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87EE78C-5492-037D-7B55-ABDAE7F628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439689C-6178-7611-F928-B63DD226E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72106EF-FFA3-5752-637D-628D5FDD6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452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5A94A27-18A8-467D-6ED1-B0EB27E30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3D60A0F-0158-5276-1BB8-24F69A41BF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99E91D9-9896-7AA8-5520-AE5BF4FE7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801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458DBE-A256-C33B-2B1F-AFB38F5534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962535-7AD1-A678-0777-4ACB8AB9F2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3F6A351-2F40-D696-8475-1673E6D308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63A5273-FA88-0EB9-B469-5F2D55EBA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ABFE86-1866-8F40-AAE7-B65AA8A73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96AC4F-D0FE-25F4-8514-F2CA89BC3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262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0D2D64-AD2A-FF72-791E-782154806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EBE523A-4E64-4252-1612-C49FBE223C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756F708-F42C-D8A0-A077-AAF3628B81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DCD0020-20A0-CD77-314D-A41A6E9D6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DEEFCE-108A-BACA-5A88-150DC667F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C3FE5D3-F063-FEC8-61DC-56DF9D5CA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762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C89435C-E322-45C3-9885-72D0A82B0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DF6270C-4E96-8850-6AE5-297B8E6E96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62050F-F572-F4EB-4A72-4C856184FA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B0FDB5-D344-4892-AC49-E54109A83DD5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AA6624-7ADB-5BE1-64E9-CC257C8CB3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DAEE75-CC46-3D4A-A33F-AEE72A2F9B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02176C-AD90-4341-8B96-C3D3A3CCF9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767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278236B3-15D1-EBC8-9C79-87F346AB63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9957036"/>
              </p:ext>
            </p:extLst>
          </p:nvPr>
        </p:nvGraphicFramePr>
        <p:xfrm>
          <a:off x="2090058" y="1"/>
          <a:ext cx="7609117" cy="6857993"/>
        </p:xfrm>
        <a:graphic>
          <a:graphicData uri="http://schemas.openxmlformats.org/drawingml/2006/table">
            <a:tbl>
              <a:tblPr/>
              <a:tblGrid>
                <a:gridCol w="1246132">
                  <a:extLst>
                    <a:ext uri="{9D8B030D-6E8A-4147-A177-3AD203B41FA5}">
                      <a16:colId xmlns:a16="http://schemas.microsoft.com/office/drawing/2014/main" val="3895794973"/>
                    </a:ext>
                  </a:extLst>
                </a:gridCol>
                <a:gridCol w="1246132">
                  <a:extLst>
                    <a:ext uri="{9D8B030D-6E8A-4147-A177-3AD203B41FA5}">
                      <a16:colId xmlns:a16="http://schemas.microsoft.com/office/drawing/2014/main" val="3343504099"/>
                    </a:ext>
                  </a:extLst>
                </a:gridCol>
                <a:gridCol w="970437">
                  <a:extLst>
                    <a:ext uri="{9D8B030D-6E8A-4147-A177-3AD203B41FA5}">
                      <a16:colId xmlns:a16="http://schemas.microsoft.com/office/drawing/2014/main" val="197720859"/>
                    </a:ext>
                  </a:extLst>
                </a:gridCol>
                <a:gridCol w="1036604">
                  <a:extLst>
                    <a:ext uri="{9D8B030D-6E8A-4147-A177-3AD203B41FA5}">
                      <a16:colId xmlns:a16="http://schemas.microsoft.com/office/drawing/2014/main" val="2290011122"/>
                    </a:ext>
                  </a:extLst>
                </a:gridCol>
                <a:gridCol w="1036604">
                  <a:extLst>
                    <a:ext uri="{9D8B030D-6E8A-4147-A177-3AD203B41FA5}">
                      <a16:colId xmlns:a16="http://schemas.microsoft.com/office/drawing/2014/main" val="2688743753"/>
                    </a:ext>
                  </a:extLst>
                </a:gridCol>
                <a:gridCol w="1036604">
                  <a:extLst>
                    <a:ext uri="{9D8B030D-6E8A-4147-A177-3AD203B41FA5}">
                      <a16:colId xmlns:a16="http://schemas.microsoft.com/office/drawing/2014/main" val="3652637201"/>
                    </a:ext>
                  </a:extLst>
                </a:gridCol>
                <a:gridCol w="1036604">
                  <a:extLst>
                    <a:ext uri="{9D8B030D-6E8A-4147-A177-3AD203B41FA5}">
                      <a16:colId xmlns:a16="http://schemas.microsoft.com/office/drawing/2014/main" val="4211170612"/>
                    </a:ext>
                  </a:extLst>
                </a:gridCol>
              </a:tblGrid>
              <a:tr h="429884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plementary Table 1: Age at enrollment and age at mortality by survival and mortality groups (n=13,174).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6080504"/>
                  </a:ext>
                </a:extLst>
              </a:tr>
              <a:tr h="2686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n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849882"/>
                  </a:ext>
                </a:extLst>
              </a:tr>
              <a:tr h="26867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ead (n=950)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ive (n=4,436)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6813536"/>
                  </a:ext>
                </a:extLst>
              </a:tr>
              <a:tr h="26867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Es components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end 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8717769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loss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5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8,0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,3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,006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522857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divorc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7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2,4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5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0,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4431982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mental illness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5,7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,8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1,4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1956027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mily violenc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5,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1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0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0454222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ysical abus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5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0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2322309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 Psychological neglect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2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7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,3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45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6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756858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sychological abus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6,7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6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5442475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umulative ACEs scor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end 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1448344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2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6.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,8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56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2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8416781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7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7,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0.6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69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8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7961687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+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1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6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0,0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11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2067667"/>
                  </a:ext>
                </a:extLst>
              </a:tr>
              <a:tr h="2082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omen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963391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ead (n=950)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ive (n=4,436)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0819020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Es components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end 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644950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loss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4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,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,246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,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4052980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divorc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6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8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1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3455420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rental mental illness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8,0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2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,8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4410617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mily violenc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7,4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1,8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5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1,8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0076772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ysical abus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7,7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0,3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7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4805472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 Psychological neglect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8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,6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,2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16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236096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1F1F1F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sychological abus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,3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4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,8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4303355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umulative ACEs score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end 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t start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1512643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7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,1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,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,840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,0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7469712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0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,7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,4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82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,5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291175"/>
                  </a:ext>
                </a:extLst>
              </a:tr>
              <a:tr h="2082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+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8,9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,0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78</a:t>
                      </a:r>
                    </a:p>
                  </a:txBody>
                  <a:tcPr marL="4262" marR="4262" marT="42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,4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6074365"/>
                  </a:ext>
                </a:extLst>
              </a:tr>
              <a:tr h="208225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Es: Adverse Childhood Experiences</a:t>
                      </a: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1650560"/>
                  </a:ext>
                </a:extLst>
              </a:tr>
              <a:tr h="208225"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62" marR="4262" marT="42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22350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33307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6</Words>
  <Application>Microsoft Office PowerPoint</Application>
  <PresentationFormat>ワイド画面</PresentationFormat>
  <Paragraphs>15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巌 千嶋</dc:creator>
  <cp:lastModifiedBy>巌 千嶋</cp:lastModifiedBy>
  <cp:revision>1</cp:revision>
  <dcterms:created xsi:type="dcterms:W3CDTF">2024-11-03T05:30:57Z</dcterms:created>
  <dcterms:modified xsi:type="dcterms:W3CDTF">2024-11-03T05:32:08Z</dcterms:modified>
</cp:coreProperties>
</file>